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59" d="100"/>
          <a:sy n="59" d="100"/>
        </p:scale>
        <p:origin x="940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8F7204C-964B-4A5B-9284-63E9EABBA47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2785E9FA-BAB5-45A7-84C7-41A33BE7F86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44E5818-029F-4FEE-B89B-CA65B07AFB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C138F-4D14-4D87-96A6-C8B5EEAA7501}" type="datetimeFigureOut">
              <a:rPr lang="zh-CN" altLang="en-US" smtClean="0"/>
              <a:t>2022/6/1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F788F72-C01C-4A81-BF96-AE27F9C289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B76DD09-EE10-4F58-AD24-F1B7C771EB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2405B6-E3D4-4105-BEAC-13EE44566ED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524889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C98690A-93CA-4206-ABCC-C2A625ED70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54F92672-2877-49E7-81FF-0AA79805C17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4161747-9F7E-47FB-85D3-B878661D41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C138F-4D14-4D87-96A6-C8B5EEAA7501}" type="datetimeFigureOut">
              <a:rPr lang="zh-CN" altLang="en-US" smtClean="0"/>
              <a:t>2022/6/1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F425443-5F28-4FBF-BA60-E60BD58543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9025692-81A3-42DA-9A29-5B848610DF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2405B6-E3D4-4105-BEAC-13EE44566ED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870872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D90FC744-6A86-45B9-B7DB-3C8E8D4DF56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D5DCFBE2-5973-45F0-A98A-842CBA5D10C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3C2194B-04C2-44D1-B92D-1FC7E9AC58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C138F-4D14-4D87-96A6-C8B5EEAA7501}" type="datetimeFigureOut">
              <a:rPr lang="zh-CN" altLang="en-US" smtClean="0"/>
              <a:t>2022/6/1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A507662-1C80-4DDC-A222-CC21DB26D5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728AB42-D7E6-4D56-B679-14BCE65D53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2405B6-E3D4-4105-BEAC-13EE44566ED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522063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1EC5D15-FCA8-4957-949E-9D3F63DA80D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2034CF5-589F-4D28-8517-0FDBABE9B17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DFB26F1-010D-4A9B-A37A-0C8AA8EA84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C138F-4D14-4D87-96A6-C8B5EEAA7501}" type="datetimeFigureOut">
              <a:rPr lang="zh-CN" altLang="en-US" smtClean="0"/>
              <a:t>2022/6/1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A8F25CE-0D7F-416A-89B3-89BFF62A7E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D81B791-9771-4E9D-9720-2E5A6AD4EF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2405B6-E3D4-4105-BEAC-13EE44566ED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382791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A05980B-5F47-4D14-8C63-4B0BFBE9F9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F9BB6B4-6CB2-45F0-95A9-4ABE659CEAC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EDC2A1A-C639-4248-BD58-33889526A8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C138F-4D14-4D87-96A6-C8B5EEAA7501}" type="datetimeFigureOut">
              <a:rPr lang="zh-CN" altLang="en-US" smtClean="0"/>
              <a:t>2022/6/1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EA518BA-89C2-466F-A8C2-EC3A10C2CE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BBB03CA-DD19-4014-B8EF-219A72BA4E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2405B6-E3D4-4105-BEAC-13EE44566ED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393242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6037C32-2573-43BE-BB10-CEAF79AD04F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3187EA7-9590-4DD7-A3CA-E1DF5A799B2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897095C4-F0BA-4F72-AA3E-5094623E19A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C3E420BA-2BF4-413E-9188-866B9A90C8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C138F-4D14-4D87-96A6-C8B5EEAA7501}" type="datetimeFigureOut">
              <a:rPr lang="zh-CN" altLang="en-US" smtClean="0"/>
              <a:t>2022/6/1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31A4E97-A6DE-4614-8A05-E872477A43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3F680E2F-40D6-4578-9057-93D5CD2FB3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2405B6-E3D4-4105-BEAC-13EE44566ED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982007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D7FF001-8D56-4FD6-9C2C-85AB2E494B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5B9BB88-0EAB-4BBE-AAD1-FC7597B2167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089B1292-0022-487A-926B-8BB7BBF5A96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210F34F3-53EF-4108-B103-909BAB25714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162A9093-A274-453D-95D7-52187488071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F4362CA7-4F0F-49E7-B5A7-951F888CF9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C138F-4D14-4D87-96A6-C8B5EEAA7501}" type="datetimeFigureOut">
              <a:rPr lang="zh-CN" altLang="en-US" smtClean="0"/>
              <a:t>2022/6/11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0EE34351-4B0D-41C2-BCAC-41C1DB281A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30FA27CE-188B-4683-814A-99FA1C500A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2405B6-E3D4-4105-BEAC-13EE44566ED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933343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968FED8-238B-4FA2-9016-45B3D375FB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D2AC9C38-7384-49E4-850A-2BB39F075E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C138F-4D14-4D87-96A6-C8B5EEAA7501}" type="datetimeFigureOut">
              <a:rPr lang="zh-CN" altLang="en-US" smtClean="0"/>
              <a:t>2022/6/11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D9FC5B72-A71F-4C47-8BC9-AA3081686C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4955C34C-AA89-4651-9F3F-9A2E96B9D6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2405B6-E3D4-4105-BEAC-13EE44566ED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510133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3367053A-8C5C-4F89-99B2-C3E2CBC2D1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C138F-4D14-4D87-96A6-C8B5EEAA7501}" type="datetimeFigureOut">
              <a:rPr lang="zh-CN" altLang="en-US" smtClean="0"/>
              <a:t>2022/6/11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289C242F-AF61-4FAB-8756-03AF5939AE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ED485652-E1A4-455E-90B4-CDF5888EA7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2405B6-E3D4-4105-BEAC-13EE44566ED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12238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EA19C2D-3B2A-48F9-BB54-20BF8A8ACC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E7AE537C-8FFC-438F-B701-9D255D102B3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2900DD93-139C-4D09-8192-5538168CA26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7FD1206-A3B3-44AF-A6CB-75C4445C82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C138F-4D14-4D87-96A6-C8B5EEAA7501}" type="datetimeFigureOut">
              <a:rPr lang="zh-CN" altLang="en-US" smtClean="0"/>
              <a:t>2022/6/1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9B73DCA5-28CF-4FF0-B74D-6757B8A36B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0D8CC8F-9552-4F52-B20C-866401F997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2405B6-E3D4-4105-BEAC-13EE44566ED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725113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5C0A86D-CCB7-41D8-A714-934A4040F7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3E92F7A1-2F8C-419B-B3F8-CC4578CBF4B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EFE4F6CE-982D-4F51-A342-46BE0E3AA1C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3CF5139D-EE1B-4E79-A6E2-D6A166092D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C138F-4D14-4D87-96A6-C8B5EEAA7501}" type="datetimeFigureOut">
              <a:rPr lang="zh-CN" altLang="en-US" smtClean="0"/>
              <a:t>2022/6/1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2CB440E-3918-4F92-82A4-D0258960DF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21B781D-5DA5-4BB2-8F70-A03418BA33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2405B6-E3D4-4105-BEAC-13EE44566ED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373557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39C54CE1-EC63-4A1F-9C96-2B98E4293F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9D5B2E8-17AB-44BC-9738-F0A8470E61E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A7714E4-D7DE-4F35-B461-571FE012BD8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CC138F-4D14-4D87-96A6-C8B5EEAA7501}" type="datetimeFigureOut">
              <a:rPr lang="zh-CN" altLang="en-US" smtClean="0"/>
              <a:t>2022/6/1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F1BFDD8-CEF2-47D8-8376-E71ADABD0DB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4A6B8E5-D897-43BC-AD72-06E42A53E2D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2405B6-E3D4-4105-BEAC-13EE44566ED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376961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jpeg"/><Relationship Id="rId13" Type="http://schemas.microsoft.com/office/2007/relationships/hdphoto" Target="../media/hdphoto6.wdp"/><Relationship Id="rId18" Type="http://schemas.openxmlformats.org/officeDocument/2006/relationships/image" Target="../media/image9.jpeg"/><Relationship Id="rId3" Type="http://schemas.microsoft.com/office/2007/relationships/hdphoto" Target="../media/hdphoto1.wdp"/><Relationship Id="rId7" Type="http://schemas.microsoft.com/office/2007/relationships/hdphoto" Target="../media/hdphoto3.wdp"/><Relationship Id="rId12" Type="http://schemas.openxmlformats.org/officeDocument/2006/relationships/image" Target="../media/image6.jpeg"/><Relationship Id="rId17" Type="http://schemas.microsoft.com/office/2007/relationships/hdphoto" Target="../media/hdphoto8.wdp"/><Relationship Id="rId2" Type="http://schemas.openxmlformats.org/officeDocument/2006/relationships/image" Target="../media/image1.jpeg"/><Relationship Id="rId16" Type="http://schemas.openxmlformats.org/officeDocument/2006/relationships/image" Target="../media/image8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jpeg"/><Relationship Id="rId11" Type="http://schemas.microsoft.com/office/2007/relationships/hdphoto" Target="../media/hdphoto5.wdp"/><Relationship Id="rId5" Type="http://schemas.microsoft.com/office/2007/relationships/hdphoto" Target="../media/hdphoto2.wdp"/><Relationship Id="rId15" Type="http://schemas.microsoft.com/office/2007/relationships/hdphoto" Target="../media/hdphoto7.wdp"/><Relationship Id="rId10" Type="http://schemas.openxmlformats.org/officeDocument/2006/relationships/image" Target="../media/image5.jpeg"/><Relationship Id="rId19" Type="http://schemas.microsoft.com/office/2007/relationships/hdphoto" Target="../media/hdphoto9.wdp"/><Relationship Id="rId4" Type="http://schemas.openxmlformats.org/officeDocument/2006/relationships/image" Target="../media/image2.jpeg"/><Relationship Id="rId9" Type="http://schemas.microsoft.com/office/2007/relationships/hdphoto" Target="../media/hdphoto4.wdp"/><Relationship Id="rId14" Type="http://schemas.openxmlformats.org/officeDocument/2006/relationships/image" Target="../media/image7.jpe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jpeg"/><Relationship Id="rId13" Type="http://schemas.microsoft.com/office/2007/relationships/hdphoto" Target="../media/hdphoto15.wdp"/><Relationship Id="rId18" Type="http://schemas.openxmlformats.org/officeDocument/2006/relationships/image" Target="../media/image18.jpeg"/><Relationship Id="rId3" Type="http://schemas.microsoft.com/office/2007/relationships/hdphoto" Target="../media/hdphoto10.wdp"/><Relationship Id="rId7" Type="http://schemas.microsoft.com/office/2007/relationships/hdphoto" Target="../media/hdphoto12.wdp"/><Relationship Id="rId12" Type="http://schemas.openxmlformats.org/officeDocument/2006/relationships/image" Target="../media/image15.jpeg"/><Relationship Id="rId17" Type="http://schemas.microsoft.com/office/2007/relationships/hdphoto" Target="../media/hdphoto17.wdp"/><Relationship Id="rId2" Type="http://schemas.openxmlformats.org/officeDocument/2006/relationships/image" Target="../media/image10.jpeg"/><Relationship Id="rId16" Type="http://schemas.openxmlformats.org/officeDocument/2006/relationships/image" Target="../media/image17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.jpeg"/><Relationship Id="rId11" Type="http://schemas.microsoft.com/office/2007/relationships/hdphoto" Target="../media/hdphoto14.wdp"/><Relationship Id="rId5" Type="http://schemas.microsoft.com/office/2007/relationships/hdphoto" Target="../media/hdphoto11.wdp"/><Relationship Id="rId15" Type="http://schemas.microsoft.com/office/2007/relationships/hdphoto" Target="../media/hdphoto16.wdp"/><Relationship Id="rId10" Type="http://schemas.openxmlformats.org/officeDocument/2006/relationships/image" Target="../media/image14.jpeg"/><Relationship Id="rId19" Type="http://schemas.microsoft.com/office/2007/relationships/hdphoto" Target="../media/hdphoto18.wdp"/><Relationship Id="rId4" Type="http://schemas.openxmlformats.org/officeDocument/2006/relationships/image" Target="../media/image11.jpeg"/><Relationship Id="rId9" Type="http://schemas.microsoft.com/office/2007/relationships/hdphoto" Target="../media/hdphoto13.wdp"/><Relationship Id="rId14" Type="http://schemas.openxmlformats.org/officeDocument/2006/relationships/image" Target="../media/image16.jpe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2.jpeg"/><Relationship Id="rId13" Type="http://schemas.microsoft.com/office/2007/relationships/hdphoto" Target="../media/hdphoto24.wdp"/><Relationship Id="rId18" Type="http://schemas.openxmlformats.org/officeDocument/2006/relationships/image" Target="../media/image27.jpeg"/><Relationship Id="rId3" Type="http://schemas.microsoft.com/office/2007/relationships/hdphoto" Target="../media/hdphoto19.wdp"/><Relationship Id="rId7" Type="http://schemas.microsoft.com/office/2007/relationships/hdphoto" Target="../media/hdphoto21.wdp"/><Relationship Id="rId12" Type="http://schemas.openxmlformats.org/officeDocument/2006/relationships/image" Target="../media/image24.jpeg"/><Relationship Id="rId17" Type="http://schemas.microsoft.com/office/2007/relationships/hdphoto" Target="../media/hdphoto26.wdp"/><Relationship Id="rId2" Type="http://schemas.openxmlformats.org/officeDocument/2006/relationships/image" Target="../media/image19.jpeg"/><Relationship Id="rId16" Type="http://schemas.openxmlformats.org/officeDocument/2006/relationships/image" Target="../media/image26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1.jpeg"/><Relationship Id="rId11" Type="http://schemas.microsoft.com/office/2007/relationships/hdphoto" Target="../media/hdphoto23.wdp"/><Relationship Id="rId5" Type="http://schemas.microsoft.com/office/2007/relationships/hdphoto" Target="../media/hdphoto20.wdp"/><Relationship Id="rId15" Type="http://schemas.microsoft.com/office/2007/relationships/hdphoto" Target="../media/hdphoto25.wdp"/><Relationship Id="rId10" Type="http://schemas.openxmlformats.org/officeDocument/2006/relationships/image" Target="../media/image23.jpeg"/><Relationship Id="rId19" Type="http://schemas.microsoft.com/office/2007/relationships/hdphoto" Target="../media/hdphoto27.wdp"/><Relationship Id="rId4" Type="http://schemas.openxmlformats.org/officeDocument/2006/relationships/image" Target="../media/image20.jpeg"/><Relationship Id="rId9" Type="http://schemas.microsoft.com/office/2007/relationships/hdphoto" Target="../media/hdphoto22.wdp"/><Relationship Id="rId14" Type="http://schemas.openxmlformats.org/officeDocument/2006/relationships/image" Target="../media/image25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3" descr="D:\我的文档\黄可欣\和平组\1研究组\100OLYMP\重新曝光 P1010001.JPG">
            <a:extLst>
              <a:ext uri="{FF2B5EF4-FFF2-40B4-BE49-F238E27FC236}">
                <a16:creationId xmlns:a16="http://schemas.microsoft.com/office/drawing/2014/main" id="{10F56573-B9CD-402E-90A0-5D675BA65D9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75000"/>
                    </a14:imgEffect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48542" y="2593873"/>
            <a:ext cx="2400000" cy="180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Picture 4" descr="D:\我的文档\黄可欣\和平组\1研究组\100OLYMP\重新曝光 P1010002.JPG">
            <a:extLst>
              <a:ext uri="{FF2B5EF4-FFF2-40B4-BE49-F238E27FC236}">
                <a16:creationId xmlns:a16="http://schemas.microsoft.com/office/drawing/2014/main" id="{FC0C5EC8-FB7B-40D4-A80E-E1D43F2EF85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80000"/>
                    </a14:imgEffect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16554" y="2529000"/>
            <a:ext cx="2400000" cy="180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F2829D26-8621-40B7-9953-46FEBC4581ED}"/>
              </a:ext>
            </a:extLst>
          </p:cNvPr>
          <p:cNvSpPr txBox="1"/>
          <p:nvPr/>
        </p:nvSpPr>
        <p:spPr>
          <a:xfrm>
            <a:off x="3847643" y="4393873"/>
            <a:ext cx="6266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×100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5974AC56-41D1-47F3-B549-54F1FDEF2B9A}"/>
              </a:ext>
            </a:extLst>
          </p:cNvPr>
          <p:cNvSpPr txBox="1"/>
          <p:nvPr/>
        </p:nvSpPr>
        <p:spPr>
          <a:xfrm>
            <a:off x="6776359" y="4329000"/>
            <a:ext cx="6266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×200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Picture 3" descr="D:\我的文档\黄可欣\基础\王慧肺脏分生第一次和第二次空白\重新曝光 P1010001.JPG">
            <a:extLst>
              <a:ext uri="{FF2B5EF4-FFF2-40B4-BE49-F238E27FC236}">
                <a16:creationId xmlns:a16="http://schemas.microsoft.com/office/drawing/2014/main" id="{67C08BBF-F1F9-4FF6-84A1-76B11D04F44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harpenSoften amount="83000"/>
                    </a14:imgEffect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68156" y="424541"/>
            <a:ext cx="2400000" cy="180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" name="Picture 4" descr="D:\我的文档\黄可欣\基础\王慧肺脏分生第一次和第二次空白\重新曝光 P1010002.JPG">
            <a:extLst>
              <a:ext uri="{FF2B5EF4-FFF2-40B4-BE49-F238E27FC236}">
                <a16:creationId xmlns:a16="http://schemas.microsoft.com/office/drawing/2014/main" id="{C0B60B99-118A-4E48-A8CD-4F56E31DC0A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sharpenSoften amount="77000"/>
                    </a14:imgEffect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14525" y="424541"/>
            <a:ext cx="2400000" cy="180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4" name="Picture 5" descr="D:\我的文档\黄可欣\基础\王慧肺脏分生第一次和第二次空白\重新曝光 P1010003.JPG">
            <a:extLst>
              <a:ext uri="{FF2B5EF4-FFF2-40B4-BE49-F238E27FC236}">
                <a16:creationId xmlns:a16="http://schemas.microsoft.com/office/drawing/2014/main" id="{C4F196F7-874E-45F0-8AC7-FBCABFE5B90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sharpenSoften amount="88000"/>
                    </a14:imgEffect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860894" y="424541"/>
            <a:ext cx="2400000" cy="180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7" name="文本框 16">
            <a:extLst>
              <a:ext uri="{FF2B5EF4-FFF2-40B4-BE49-F238E27FC236}">
                <a16:creationId xmlns:a16="http://schemas.microsoft.com/office/drawing/2014/main" id="{1355A05A-99B4-4FE6-8DFF-6A72478FC11A}"/>
              </a:ext>
            </a:extLst>
          </p:cNvPr>
          <p:cNvSpPr txBox="1"/>
          <p:nvPr/>
        </p:nvSpPr>
        <p:spPr>
          <a:xfrm>
            <a:off x="141513" y="55209"/>
            <a:ext cx="18070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PBS group</a:t>
            </a:r>
            <a:r>
              <a:rPr lang="zh-CN" altLang="en-US" b="1" dirty="0">
                <a:latin typeface="Arial" panose="020B0604020202020204" pitchFamily="34" charset="0"/>
                <a:cs typeface="Arial" panose="020B0604020202020204" pitchFamily="34" charset="0"/>
              </a:rPr>
              <a:t>：</a:t>
            </a: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B3C40E1F-3449-4E26-B7E6-6126C0ACA11E}"/>
              </a:ext>
            </a:extLst>
          </p:cNvPr>
          <p:cNvSpPr txBox="1"/>
          <p:nvPr/>
        </p:nvSpPr>
        <p:spPr>
          <a:xfrm>
            <a:off x="326570" y="955209"/>
            <a:ext cx="13955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Mouse 1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：</a:t>
            </a:r>
          </a:p>
        </p:txBody>
      </p:sp>
      <p:pic>
        <p:nvPicPr>
          <p:cNvPr id="19" name="Picture 5" descr="D:\我的文档\黄可欣\和平组\1研究组\100OLYMP\重新曝光 P1010003.JPG">
            <a:extLst>
              <a:ext uri="{FF2B5EF4-FFF2-40B4-BE49-F238E27FC236}">
                <a16:creationId xmlns:a16="http://schemas.microsoft.com/office/drawing/2014/main" id="{4D3F188A-957C-4C13-AEFA-09600390495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sharpenSoften amount="88000"/>
                    </a14:imgEffect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843458" y="2567364"/>
            <a:ext cx="2400000" cy="180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0" name="文本框 19">
            <a:extLst>
              <a:ext uri="{FF2B5EF4-FFF2-40B4-BE49-F238E27FC236}">
                <a16:creationId xmlns:a16="http://schemas.microsoft.com/office/drawing/2014/main" id="{93668442-F48D-48B6-A25E-6FA12BB348F9}"/>
              </a:ext>
            </a:extLst>
          </p:cNvPr>
          <p:cNvSpPr txBox="1"/>
          <p:nvPr/>
        </p:nvSpPr>
        <p:spPr>
          <a:xfrm>
            <a:off x="9830863" y="4393872"/>
            <a:ext cx="6266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×400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7B7A84EB-043F-4918-AE53-9082A4AFA498}"/>
              </a:ext>
            </a:extLst>
          </p:cNvPr>
          <p:cNvSpPr txBox="1"/>
          <p:nvPr/>
        </p:nvSpPr>
        <p:spPr>
          <a:xfrm>
            <a:off x="3945614" y="2238271"/>
            <a:ext cx="6266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×100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ADE7ED6A-D075-499B-B677-BAEBAE138A9A}"/>
              </a:ext>
            </a:extLst>
          </p:cNvPr>
          <p:cNvSpPr txBox="1"/>
          <p:nvPr/>
        </p:nvSpPr>
        <p:spPr>
          <a:xfrm>
            <a:off x="6874330" y="2173398"/>
            <a:ext cx="6266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×200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AD41C136-5C2E-49FF-A503-26822B56BE6D}"/>
              </a:ext>
            </a:extLst>
          </p:cNvPr>
          <p:cNvSpPr txBox="1"/>
          <p:nvPr/>
        </p:nvSpPr>
        <p:spPr>
          <a:xfrm>
            <a:off x="9830862" y="2238270"/>
            <a:ext cx="6266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×400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8DCE779E-A2BE-43E2-8FCB-169E59B50467}"/>
              </a:ext>
            </a:extLst>
          </p:cNvPr>
          <p:cNvSpPr txBox="1"/>
          <p:nvPr/>
        </p:nvSpPr>
        <p:spPr>
          <a:xfrm>
            <a:off x="326570" y="3309207"/>
            <a:ext cx="13955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Mouse 2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：</a:t>
            </a: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4939B64B-4854-4867-885A-1D3F4919D511}"/>
              </a:ext>
            </a:extLst>
          </p:cNvPr>
          <p:cNvSpPr txBox="1"/>
          <p:nvPr/>
        </p:nvSpPr>
        <p:spPr>
          <a:xfrm>
            <a:off x="326570" y="5293873"/>
            <a:ext cx="13955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Mouse 3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：</a:t>
            </a:r>
          </a:p>
        </p:txBody>
      </p:sp>
      <p:pic>
        <p:nvPicPr>
          <p:cNvPr id="26" name="Picture 2" descr="D:\我的文档\黄可欣\基础\王慧肺脏分生第一次和第二次空白\重新曝光 P1010006.JPG">
            <a:extLst>
              <a:ext uri="{FF2B5EF4-FFF2-40B4-BE49-F238E27FC236}">
                <a16:creationId xmlns:a16="http://schemas.microsoft.com/office/drawing/2014/main" id="{E7BE593E-3372-4CC3-ABCE-DB03360E312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4" cstate="print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sharpenSoften amount="84000"/>
                    </a14:imgEffect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843458" y="4710187"/>
            <a:ext cx="2400000" cy="180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7" name="Picture 6" descr="D:\我的文档\黄可欣\基础\王慧肺脏分生第一次和第二次空白\重新曝光 P1010004.JPG">
            <a:extLst>
              <a:ext uri="{FF2B5EF4-FFF2-40B4-BE49-F238E27FC236}">
                <a16:creationId xmlns:a16="http://schemas.microsoft.com/office/drawing/2014/main" id="{A8B037AF-F4E8-40FB-9ECF-6B18F06CBF6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6" cstate="print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sharpenSoften amount="79000"/>
                    </a14:imgEffect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70185" y="4774661"/>
            <a:ext cx="2400000" cy="180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8" name="Picture 7" descr="D:\我的文档\黄可欣\基础\王慧肺脏分生第一次和第二次空白\重新曝光 P1010005.JPG">
            <a:extLst>
              <a:ext uri="{FF2B5EF4-FFF2-40B4-BE49-F238E27FC236}">
                <a16:creationId xmlns:a16="http://schemas.microsoft.com/office/drawing/2014/main" id="{93A23026-FE2D-4ADF-AAC5-2A72B8EFCCB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8" cstate="print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sharpenSoften amount="79000"/>
                    </a14:imgEffect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16554" y="4714364"/>
            <a:ext cx="2400000" cy="180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9" name="文本框 28">
            <a:extLst>
              <a:ext uri="{FF2B5EF4-FFF2-40B4-BE49-F238E27FC236}">
                <a16:creationId xmlns:a16="http://schemas.microsoft.com/office/drawing/2014/main" id="{1882A8FA-ED1C-49A4-BB08-43B558930B40}"/>
              </a:ext>
            </a:extLst>
          </p:cNvPr>
          <p:cNvSpPr txBox="1"/>
          <p:nvPr/>
        </p:nvSpPr>
        <p:spPr>
          <a:xfrm>
            <a:off x="3836756" y="6538362"/>
            <a:ext cx="6266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×100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6285A4F0-1C43-414B-893B-E3615C16ACCE}"/>
              </a:ext>
            </a:extLst>
          </p:cNvPr>
          <p:cNvSpPr txBox="1"/>
          <p:nvPr/>
        </p:nvSpPr>
        <p:spPr>
          <a:xfrm>
            <a:off x="6765472" y="6473489"/>
            <a:ext cx="6266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×200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5D5DA839-D39B-467A-881D-05DAD8A6FC8D}"/>
              </a:ext>
            </a:extLst>
          </p:cNvPr>
          <p:cNvSpPr txBox="1"/>
          <p:nvPr/>
        </p:nvSpPr>
        <p:spPr>
          <a:xfrm>
            <a:off x="9819976" y="6538361"/>
            <a:ext cx="6266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×400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7712459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A295F9EB-D44B-4693-839C-F03D4F527937}"/>
              </a:ext>
            </a:extLst>
          </p:cNvPr>
          <p:cNvSpPr txBox="1"/>
          <p:nvPr/>
        </p:nvSpPr>
        <p:spPr>
          <a:xfrm>
            <a:off x="141513" y="55209"/>
            <a:ext cx="18070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LPS group</a:t>
            </a:r>
            <a:r>
              <a:rPr lang="zh-CN" altLang="en-US" b="1" dirty="0">
                <a:latin typeface="Arial" panose="020B0604020202020204" pitchFamily="34" charset="0"/>
                <a:cs typeface="Arial" panose="020B0604020202020204" pitchFamily="34" charset="0"/>
              </a:rPr>
              <a:t>：</a:t>
            </a:r>
          </a:p>
        </p:txBody>
      </p:sp>
      <p:pic>
        <p:nvPicPr>
          <p:cNvPr id="5" name="Picture 9" descr="D:\我的文档\黄可欣\100OLYMP\王慧肺脏分生3.20\重新曝光 P1010070.JPG">
            <a:extLst>
              <a:ext uri="{FF2B5EF4-FFF2-40B4-BE49-F238E27FC236}">
                <a16:creationId xmlns:a16="http://schemas.microsoft.com/office/drawing/2014/main" id="{661B55D5-7F0F-43BC-9BC6-A05A10122FE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75000"/>
                    </a14:imgEffect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37113" y="162943"/>
            <a:ext cx="2400000" cy="180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Picture 10" descr="D:\我的文档\黄可欣\100OLYMP\王慧肺脏分生3.20\重新曝光 P1010071.JPG">
            <a:extLst>
              <a:ext uri="{FF2B5EF4-FFF2-40B4-BE49-F238E27FC236}">
                <a16:creationId xmlns:a16="http://schemas.microsoft.com/office/drawing/2014/main" id="{C1FB1FAF-7573-423A-B80F-66CD9EEB069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7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76257" y="162943"/>
            <a:ext cx="2400000" cy="180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" name="Picture 11" descr="D:\我的文档\黄可欣\100OLYMP\王慧肺脏分生3.20\重新曝光 P1010072.JPG">
            <a:extLst>
              <a:ext uri="{FF2B5EF4-FFF2-40B4-BE49-F238E27FC236}">
                <a16:creationId xmlns:a16="http://schemas.microsoft.com/office/drawing/2014/main" id="{05736FFE-A310-476F-9D82-56A8AA5A4F4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harpenSoften amount="84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715399" y="162943"/>
            <a:ext cx="2400000" cy="180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EC4E87E1-9D19-4ECC-BB07-AF7356D670A4}"/>
              </a:ext>
            </a:extLst>
          </p:cNvPr>
          <p:cNvSpPr txBox="1"/>
          <p:nvPr/>
        </p:nvSpPr>
        <p:spPr>
          <a:xfrm>
            <a:off x="441545" y="878277"/>
            <a:ext cx="13955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Mouse 1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：</a:t>
            </a: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7A9DEFD7-5719-43DD-9BEA-951B6EF64427}"/>
              </a:ext>
            </a:extLst>
          </p:cNvPr>
          <p:cNvSpPr txBox="1"/>
          <p:nvPr/>
        </p:nvSpPr>
        <p:spPr>
          <a:xfrm>
            <a:off x="3727899" y="2016930"/>
            <a:ext cx="6266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×100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D97B86A6-5C3E-4AE1-BB8B-FF80CC523BCA}"/>
              </a:ext>
            </a:extLst>
          </p:cNvPr>
          <p:cNvSpPr txBox="1"/>
          <p:nvPr/>
        </p:nvSpPr>
        <p:spPr>
          <a:xfrm>
            <a:off x="6656615" y="1952057"/>
            <a:ext cx="6266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×200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BC778E30-2956-4970-A5C4-E21DF5EA0353}"/>
              </a:ext>
            </a:extLst>
          </p:cNvPr>
          <p:cNvSpPr txBox="1"/>
          <p:nvPr/>
        </p:nvSpPr>
        <p:spPr>
          <a:xfrm>
            <a:off x="9613147" y="2016929"/>
            <a:ext cx="6266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×400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Picture 6" descr="D:\我的文档\黄可欣\100OLYMP\王慧肺脏分生3.20\重新曝光 P1010067.JPG">
            <a:extLst>
              <a:ext uri="{FF2B5EF4-FFF2-40B4-BE49-F238E27FC236}">
                <a16:creationId xmlns:a16="http://schemas.microsoft.com/office/drawing/2014/main" id="{DD4C5410-D39D-4F81-8560-DA639424D9A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sharpenSoften amount="72000"/>
                    </a14:imgEffect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58341" y="2409227"/>
            <a:ext cx="2400000" cy="180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" name="Picture 7" descr="D:\我的文档\黄可欣\100OLYMP\王慧肺脏分生3.20\重新曝光 P1010068.JPG">
            <a:extLst>
              <a:ext uri="{FF2B5EF4-FFF2-40B4-BE49-F238E27FC236}">
                <a16:creationId xmlns:a16="http://schemas.microsoft.com/office/drawing/2014/main" id="{40BB9723-907A-4C36-B1DC-83330DB1585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sharpenSoften amount="83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87143" y="2409227"/>
            <a:ext cx="2400000" cy="180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4" name="Picture 8" descr="D:\我的文档\黄可欣\100OLYMP\王慧肺脏分生3.20\重新曝光 P1010069.JPG">
            <a:extLst>
              <a:ext uri="{FF2B5EF4-FFF2-40B4-BE49-F238E27FC236}">
                <a16:creationId xmlns:a16="http://schemas.microsoft.com/office/drawing/2014/main" id="{79D743EE-34E2-4BF3-9544-E6473191A62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sharpenSoften amount="88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726285" y="2409227"/>
            <a:ext cx="2400000" cy="180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5" name="文本框 14">
            <a:extLst>
              <a:ext uri="{FF2B5EF4-FFF2-40B4-BE49-F238E27FC236}">
                <a16:creationId xmlns:a16="http://schemas.microsoft.com/office/drawing/2014/main" id="{BD109C95-B489-4BA0-BF87-89EC448B9BFB}"/>
              </a:ext>
            </a:extLst>
          </p:cNvPr>
          <p:cNvSpPr txBox="1"/>
          <p:nvPr/>
        </p:nvSpPr>
        <p:spPr>
          <a:xfrm>
            <a:off x="3738785" y="4286130"/>
            <a:ext cx="6266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×100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3EFA77B6-8E7A-48CC-93C8-AD8D77A723A5}"/>
              </a:ext>
            </a:extLst>
          </p:cNvPr>
          <p:cNvSpPr txBox="1"/>
          <p:nvPr/>
        </p:nvSpPr>
        <p:spPr>
          <a:xfrm>
            <a:off x="6667501" y="4221257"/>
            <a:ext cx="6266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×200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74CFD32B-F1E2-48BA-B481-A4F00A01F472}"/>
              </a:ext>
            </a:extLst>
          </p:cNvPr>
          <p:cNvSpPr txBox="1"/>
          <p:nvPr/>
        </p:nvSpPr>
        <p:spPr>
          <a:xfrm>
            <a:off x="9624033" y="4286129"/>
            <a:ext cx="6266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×400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4262FBED-E0CF-477A-9DC4-D7D4E21B1138}"/>
              </a:ext>
            </a:extLst>
          </p:cNvPr>
          <p:cNvSpPr txBox="1"/>
          <p:nvPr/>
        </p:nvSpPr>
        <p:spPr>
          <a:xfrm>
            <a:off x="376230" y="3124561"/>
            <a:ext cx="13955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Mouse 2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：</a:t>
            </a:r>
          </a:p>
        </p:txBody>
      </p:sp>
      <p:pic>
        <p:nvPicPr>
          <p:cNvPr id="19" name="Picture 15" descr="D:\我的文档\黄可欣\100OLYMP\王慧肺脏分生3.20\重新曝光 P1010094.JPG">
            <a:extLst>
              <a:ext uri="{FF2B5EF4-FFF2-40B4-BE49-F238E27FC236}">
                <a16:creationId xmlns:a16="http://schemas.microsoft.com/office/drawing/2014/main" id="{BD9B0474-8B8F-49E2-8A37-2BBDABA830D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4" cstate="print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sharpenSoften amount="76000"/>
                    </a14:imgEffect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58341" y="4640032"/>
            <a:ext cx="2400000" cy="180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" name="Picture 16" descr="D:\我的文档\黄可欣\100OLYMP\王慧肺脏分生3.20\重新曝光 P1010095.JPG">
            <a:extLst>
              <a:ext uri="{FF2B5EF4-FFF2-40B4-BE49-F238E27FC236}">
                <a16:creationId xmlns:a16="http://schemas.microsoft.com/office/drawing/2014/main" id="{18D074C5-75F3-4EC3-B82E-E9A95DE5B77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6" cstate="print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sharpenSoften amount="70000"/>
                    </a14:imgEffect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54597" y="4674296"/>
            <a:ext cx="2400000" cy="180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1" name="Picture 17" descr="D:\我的文档\黄可欣\100OLYMP\王慧肺脏分生3.20\重新曝光 P1010096.JPG">
            <a:extLst>
              <a:ext uri="{FF2B5EF4-FFF2-40B4-BE49-F238E27FC236}">
                <a16:creationId xmlns:a16="http://schemas.microsoft.com/office/drawing/2014/main" id="{FD3E2794-C7F0-4B0E-85B7-DFA290AC368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8" cstate="print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sharpenSoften amount="83000"/>
                    </a14:imgEffect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750853" y="4644343"/>
            <a:ext cx="2400000" cy="180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2" name="文本框 21">
            <a:extLst>
              <a:ext uri="{FF2B5EF4-FFF2-40B4-BE49-F238E27FC236}">
                <a16:creationId xmlns:a16="http://schemas.microsoft.com/office/drawing/2014/main" id="{5830672E-B1B7-48D9-B0CE-AE40F651984C}"/>
              </a:ext>
            </a:extLst>
          </p:cNvPr>
          <p:cNvSpPr txBox="1"/>
          <p:nvPr/>
        </p:nvSpPr>
        <p:spPr>
          <a:xfrm>
            <a:off x="3752353" y="6476142"/>
            <a:ext cx="6266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×100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18A733F1-77E9-43BC-B89B-3D7B3C7D2CF4}"/>
              </a:ext>
            </a:extLst>
          </p:cNvPr>
          <p:cNvSpPr txBox="1"/>
          <p:nvPr/>
        </p:nvSpPr>
        <p:spPr>
          <a:xfrm>
            <a:off x="6681069" y="6411269"/>
            <a:ext cx="6266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×200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D2BD72C6-EAAE-46A0-AFCC-AA4CEF536D5C}"/>
              </a:ext>
            </a:extLst>
          </p:cNvPr>
          <p:cNvSpPr txBox="1"/>
          <p:nvPr/>
        </p:nvSpPr>
        <p:spPr>
          <a:xfrm>
            <a:off x="9637601" y="6476141"/>
            <a:ext cx="6266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×400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96214F53-ED77-4C8E-9395-05158D54CD52}"/>
              </a:ext>
            </a:extLst>
          </p:cNvPr>
          <p:cNvSpPr txBox="1"/>
          <p:nvPr/>
        </p:nvSpPr>
        <p:spPr>
          <a:xfrm>
            <a:off x="441545" y="5355366"/>
            <a:ext cx="13955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Mouse 3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：</a:t>
            </a:r>
          </a:p>
        </p:txBody>
      </p:sp>
    </p:spTree>
    <p:extLst>
      <p:ext uri="{BB962C8B-B14F-4D97-AF65-F5344CB8AC3E}">
        <p14:creationId xmlns:p14="http://schemas.microsoft.com/office/powerpoint/2010/main" val="147148106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BC532614-E182-4CA4-A02E-11FC6FE12F2C}"/>
              </a:ext>
            </a:extLst>
          </p:cNvPr>
          <p:cNvSpPr txBox="1"/>
          <p:nvPr/>
        </p:nvSpPr>
        <p:spPr>
          <a:xfrm>
            <a:off x="141513" y="55209"/>
            <a:ext cx="24275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LPS+MS19 group</a:t>
            </a:r>
            <a:r>
              <a:rPr lang="zh-CN" altLang="en-US" b="1" dirty="0">
                <a:latin typeface="Arial" panose="020B0604020202020204" pitchFamily="34" charset="0"/>
                <a:cs typeface="Arial" panose="020B0604020202020204" pitchFamily="34" charset="0"/>
              </a:rPr>
              <a:t>：</a:t>
            </a:r>
          </a:p>
        </p:txBody>
      </p:sp>
      <p:pic>
        <p:nvPicPr>
          <p:cNvPr id="5" name="Picture 6" descr="D:\我的文档\黄可欣\基础\王慧7.12\重新曝光 P1010031.JPG">
            <a:extLst>
              <a:ext uri="{FF2B5EF4-FFF2-40B4-BE49-F238E27FC236}">
                <a16:creationId xmlns:a16="http://schemas.microsoft.com/office/drawing/2014/main" id="{A0C375F7-D045-4B72-A8D3-921CFF5D89A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76000"/>
                    </a14:imgEffect>
                    <a14:imgEffect>
                      <a14:brightnessContrast bright="5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50739" y="424541"/>
            <a:ext cx="2400000" cy="180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Picture 7" descr="D:\我的文档\黄可欣\基础\王慧7.12\重新曝光 P1010032.JPG">
            <a:extLst>
              <a:ext uri="{FF2B5EF4-FFF2-40B4-BE49-F238E27FC236}">
                <a16:creationId xmlns:a16="http://schemas.microsoft.com/office/drawing/2014/main" id="{25D67770-1754-487F-B2B6-6D491CE6734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86000"/>
                    </a14:imgEffect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99255" y="429228"/>
            <a:ext cx="2400000" cy="180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" name="Picture 8" descr="D:\我的文档\黄可欣\基础\王慧7.12\重新曝光 P1010033.JPG">
            <a:extLst>
              <a:ext uri="{FF2B5EF4-FFF2-40B4-BE49-F238E27FC236}">
                <a16:creationId xmlns:a16="http://schemas.microsoft.com/office/drawing/2014/main" id="{7061B9E2-6F3D-4946-BA61-D343813402C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harpenSoften amount="89000"/>
                    </a14:imgEffect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947771" y="467348"/>
            <a:ext cx="2400000" cy="180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77E1E1D8-1477-4D81-B4D1-0C53E3BADCF8}"/>
              </a:ext>
            </a:extLst>
          </p:cNvPr>
          <p:cNvSpPr txBox="1"/>
          <p:nvPr/>
        </p:nvSpPr>
        <p:spPr>
          <a:xfrm>
            <a:off x="441545" y="878277"/>
            <a:ext cx="13955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Mouse 1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：</a:t>
            </a: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2FCF13CF-5A0E-45B4-A6C5-C8C19511EDE5}"/>
              </a:ext>
            </a:extLst>
          </p:cNvPr>
          <p:cNvSpPr txBox="1"/>
          <p:nvPr/>
        </p:nvSpPr>
        <p:spPr>
          <a:xfrm>
            <a:off x="3935714" y="2224541"/>
            <a:ext cx="6266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×100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896C3646-B2A2-40FA-BCA0-FD9497DACD57}"/>
              </a:ext>
            </a:extLst>
          </p:cNvPr>
          <p:cNvSpPr txBox="1"/>
          <p:nvPr/>
        </p:nvSpPr>
        <p:spPr>
          <a:xfrm>
            <a:off x="6884230" y="2206282"/>
            <a:ext cx="6266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×200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804EC81B-1AD5-4F72-ADEF-B312F684D3D9}"/>
              </a:ext>
            </a:extLst>
          </p:cNvPr>
          <p:cNvSpPr txBox="1"/>
          <p:nvPr/>
        </p:nvSpPr>
        <p:spPr>
          <a:xfrm>
            <a:off x="9838231" y="2267348"/>
            <a:ext cx="6266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×400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Picture 2" descr="D:\我的文档\黄可欣\基础\王慧7.12\重新曝光 P1010027.JPG">
            <a:extLst>
              <a:ext uri="{FF2B5EF4-FFF2-40B4-BE49-F238E27FC236}">
                <a16:creationId xmlns:a16="http://schemas.microsoft.com/office/drawing/2014/main" id="{470C8266-B3E8-4B3F-A5AB-42E0BA5CF9C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sharpenSoften amount="10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947771" y="2593873"/>
            <a:ext cx="2400000" cy="180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" name="Picture 15" descr="D:\我的文档\黄可欣\基础\王慧7.12\重新曝光 P1010025.JPG">
            <a:extLst>
              <a:ext uri="{FF2B5EF4-FFF2-40B4-BE49-F238E27FC236}">
                <a16:creationId xmlns:a16="http://schemas.microsoft.com/office/drawing/2014/main" id="{CF964D41-9D98-497F-AFBE-52F9FC66F2E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sharpenSoften amount="72000"/>
                    </a14:imgEffect>
                    <a14:imgEffect>
                      <a14:brightnessContrast bright="5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50739" y="2593873"/>
            <a:ext cx="2400000" cy="180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4" name="Picture 16" descr="D:\我的文档\黄可欣\基础\王慧7.12\重新曝光 P1010026.JPG">
            <a:extLst>
              <a:ext uri="{FF2B5EF4-FFF2-40B4-BE49-F238E27FC236}">
                <a16:creationId xmlns:a16="http://schemas.microsoft.com/office/drawing/2014/main" id="{926EE0F3-FCFB-4291-973F-3588C114A18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sharpenSoften amount="9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99255" y="2593873"/>
            <a:ext cx="2400000" cy="180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5" name="文本框 14">
            <a:extLst>
              <a:ext uri="{FF2B5EF4-FFF2-40B4-BE49-F238E27FC236}">
                <a16:creationId xmlns:a16="http://schemas.microsoft.com/office/drawing/2014/main" id="{22C581D2-6D1F-41BA-9CD3-2EBD5EC54A48}"/>
              </a:ext>
            </a:extLst>
          </p:cNvPr>
          <p:cNvSpPr txBox="1"/>
          <p:nvPr/>
        </p:nvSpPr>
        <p:spPr>
          <a:xfrm>
            <a:off x="3954455" y="4392979"/>
            <a:ext cx="6266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×100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3C845CD6-2987-468E-8345-366AA7BE6D55}"/>
              </a:ext>
            </a:extLst>
          </p:cNvPr>
          <p:cNvSpPr txBox="1"/>
          <p:nvPr/>
        </p:nvSpPr>
        <p:spPr>
          <a:xfrm>
            <a:off x="6902971" y="4374720"/>
            <a:ext cx="6266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×200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E30AC58C-8751-44FA-B3D3-AB53DD9CD2F5}"/>
              </a:ext>
            </a:extLst>
          </p:cNvPr>
          <p:cNvSpPr txBox="1"/>
          <p:nvPr/>
        </p:nvSpPr>
        <p:spPr>
          <a:xfrm>
            <a:off x="9856972" y="4435786"/>
            <a:ext cx="6266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×400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8" name="Picture 3" descr="D:\我的文档\黄可欣\100OLYMP\王慧肺脏分生3.20\重新曝光 P1010082.JPG">
            <a:extLst>
              <a:ext uri="{FF2B5EF4-FFF2-40B4-BE49-F238E27FC236}">
                <a16:creationId xmlns:a16="http://schemas.microsoft.com/office/drawing/2014/main" id="{F45CAD53-D8D5-4B44-9500-05C0A19AC34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4" cstate="print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sharpenSoften amount="84000"/>
                    </a14:imgEffect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50739" y="4770128"/>
            <a:ext cx="2400000" cy="180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9" name="Picture 4" descr="D:\我的文档\黄可欣\100OLYMP\王慧肺脏分生3.20\重新曝光 P1010083.JPG">
            <a:extLst>
              <a:ext uri="{FF2B5EF4-FFF2-40B4-BE49-F238E27FC236}">
                <a16:creationId xmlns:a16="http://schemas.microsoft.com/office/drawing/2014/main" id="{A205DC05-19BA-4765-903E-22F486E0C0B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6" cstate="print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sharpenSoften amount="76000"/>
                    </a14:imgEffect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99255" y="4743158"/>
            <a:ext cx="2400000" cy="180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" name="Picture 5" descr="D:\我的文档\黄可欣\100OLYMP\王慧肺脏分生3.20\重新曝光 P1010084.JPG">
            <a:extLst>
              <a:ext uri="{FF2B5EF4-FFF2-40B4-BE49-F238E27FC236}">
                <a16:creationId xmlns:a16="http://schemas.microsoft.com/office/drawing/2014/main" id="{1B586792-B090-46CA-A7B6-7635D6D1810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8" cstate="print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sharpenSoften amount="91000"/>
                    </a14:imgEffect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947771" y="4754698"/>
            <a:ext cx="2400000" cy="180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1" name="文本框 20">
            <a:extLst>
              <a:ext uri="{FF2B5EF4-FFF2-40B4-BE49-F238E27FC236}">
                <a16:creationId xmlns:a16="http://schemas.microsoft.com/office/drawing/2014/main" id="{EA4ACF84-14FF-431A-A3C0-26CDCA901044}"/>
              </a:ext>
            </a:extLst>
          </p:cNvPr>
          <p:cNvSpPr txBox="1"/>
          <p:nvPr/>
        </p:nvSpPr>
        <p:spPr>
          <a:xfrm>
            <a:off x="3987112" y="6570122"/>
            <a:ext cx="6266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×100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5C6224A4-CEEA-4138-89F2-C5C1A7F48FBC}"/>
              </a:ext>
            </a:extLst>
          </p:cNvPr>
          <p:cNvSpPr txBox="1"/>
          <p:nvPr/>
        </p:nvSpPr>
        <p:spPr>
          <a:xfrm>
            <a:off x="6935628" y="6551863"/>
            <a:ext cx="6266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×200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33217D6F-F873-4886-93AB-B2FCE0AAA3B4}"/>
              </a:ext>
            </a:extLst>
          </p:cNvPr>
          <p:cNvSpPr txBox="1"/>
          <p:nvPr/>
        </p:nvSpPr>
        <p:spPr>
          <a:xfrm>
            <a:off x="9889629" y="6612929"/>
            <a:ext cx="6266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×400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B35C09E0-86E3-4E40-8C78-E277F58A588A}"/>
              </a:ext>
            </a:extLst>
          </p:cNvPr>
          <p:cNvSpPr txBox="1"/>
          <p:nvPr/>
        </p:nvSpPr>
        <p:spPr>
          <a:xfrm>
            <a:off x="524768" y="3309207"/>
            <a:ext cx="13955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Mouse 2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：</a:t>
            </a: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6ACCF588-5A01-498E-BAC0-E5BAD61B50E6}"/>
              </a:ext>
            </a:extLst>
          </p:cNvPr>
          <p:cNvSpPr txBox="1"/>
          <p:nvPr/>
        </p:nvSpPr>
        <p:spPr>
          <a:xfrm>
            <a:off x="637943" y="5470032"/>
            <a:ext cx="13955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Mouse 3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：</a:t>
            </a:r>
          </a:p>
        </p:txBody>
      </p:sp>
    </p:spTree>
    <p:extLst>
      <p:ext uri="{BB962C8B-B14F-4D97-AF65-F5344CB8AC3E}">
        <p14:creationId xmlns:p14="http://schemas.microsoft.com/office/powerpoint/2010/main" val="2974864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1</TotalTime>
  <Words>92</Words>
  <Application>Microsoft Office PowerPoint</Application>
  <PresentationFormat>宽屏</PresentationFormat>
  <Paragraphs>39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7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ing Yang</dc:creator>
  <cp:lastModifiedBy>Ming Yang</cp:lastModifiedBy>
  <cp:revision>19</cp:revision>
  <dcterms:created xsi:type="dcterms:W3CDTF">2022-06-11T08:15:54Z</dcterms:created>
  <dcterms:modified xsi:type="dcterms:W3CDTF">2022-06-11T08:48:47Z</dcterms:modified>
</cp:coreProperties>
</file>